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jpeg" ContentType="image/jpeg"/>
  <Override PartName="/ppt/media/image3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92EDD-6AE4-404D-8806-D3788A3842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B71C3-35AA-44EA-A5DB-BB80A0694F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CE01F-789E-466C-A502-041D281A86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18B1A-CC6B-4B6C-8F1D-14C9A764CF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EE011-C43B-450D-B113-DB29689AB3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F7925-0950-4BA9-8F5C-6FAD7E5B43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DEAA0-EE8B-4739-BE66-0AAAC58586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0C4A0-3C13-406B-8130-3964F0200B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5FB3A-3AF9-42F8-B8DD-AF38A34941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90722-F105-40BA-A167-D22B8C9631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9C54A-5C91-40AE-B81A-1ECF34271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50F21-A6CE-4A53-83F6-E06A6E378D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1F60E2-A16D-4F34-90A3-0E589A940E07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package" Target="../embeddings/oleObject1.xlsx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867" t="0" r="1914" b="-5118"/>
          <a:stretch/>
        </p:blipFill>
        <p:spPr>
          <a:xfrm>
            <a:off x="1773360" y="2790720"/>
            <a:ext cx="3981240" cy="576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58960" y="1782720"/>
            <a:ext cx="93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600" spc="-1" strike="noStrike">
                <a:solidFill>
                  <a:srgbClr val="000000"/>
                </a:solidFill>
                <a:latin typeface="Arial"/>
              </a:rPr>
              <a:t>p-Ra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60400" y="2293920"/>
            <a:ext cx="93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600" spc="-1" strike="noStrike">
                <a:solidFill>
                  <a:srgbClr val="000000"/>
                </a:solidFill>
                <a:latin typeface="Arial"/>
              </a:rPr>
              <a:t>t-Ra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65000" y="2870280"/>
            <a:ext cx="93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22600" y="1351080"/>
            <a:ext cx="79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43320" y="136836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46240" y="136836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51320" y="136836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30600" y="136836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612040" y="136836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565360" y="99216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538960" y="99216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138840" y="631800"/>
            <a:ext cx="175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400" spc="-1" strike="noStrike">
                <a:solidFill>
                  <a:srgbClr val="000000"/>
                </a:solidFill>
                <a:latin typeface="Arial"/>
              </a:rPr>
              <a:t>Mevalonate 0.2m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565360" y="992160"/>
            <a:ext cx="297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2"/>
          <a:srcRect l="3483" t="0" r="0" b="0"/>
          <a:stretch/>
        </p:blipFill>
        <p:spPr>
          <a:xfrm>
            <a:off x="1793880" y="2216160"/>
            <a:ext cx="3960720" cy="50328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4027320" y="136836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106960" y="137628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1793880" y="1639800"/>
            <a:ext cx="3960720" cy="5032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9" name=""/>
          <p:cNvGraphicFramePr/>
          <p:nvPr/>
        </p:nvGraphicFramePr>
        <p:xfrm>
          <a:off x="1746360" y="3873600"/>
          <a:ext cx="4032000" cy="249552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746360" y="3873600"/>
                    <a:ext cx="4032000" cy="2495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1" name=""/>
          <p:cNvSpPr/>
          <p:nvPr/>
        </p:nvSpPr>
        <p:spPr>
          <a:xfrm>
            <a:off x="1628640" y="6302520"/>
            <a:ext cx="90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467080" y="63198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970360" y="63198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475080" y="63198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554360" y="631980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635800" y="631980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637000" y="6681960"/>
            <a:ext cx="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562720" y="66564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162960" y="6872400"/>
            <a:ext cx="175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400" spc="-1" strike="noStrike">
                <a:solidFill>
                  <a:srgbClr val="000000"/>
                </a:solidFill>
                <a:latin typeface="Arial"/>
              </a:rPr>
              <a:t>Mevalonate 0.2m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2637000" y="6800760"/>
            <a:ext cx="2925720" cy="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051440" y="63198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130720" y="632772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-27720" y="4925160"/>
            <a:ext cx="2589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600" spc="-1" strike="noStrike">
                <a:solidFill>
                  <a:srgbClr val="000000"/>
                </a:solidFill>
                <a:latin typeface="Arial"/>
              </a:rPr>
              <a:t>p-Rac protein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600" spc="-1" strike="noStrike">
                <a:solidFill>
                  <a:srgbClr val="000000"/>
                </a:solidFill>
                <a:latin typeface="Arial"/>
              </a:rPr>
              <a:t>(fold of control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314360" y="600876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314360" y="449748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22440" y="668160"/>
            <a:ext cx="718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22440" y="3657600"/>
            <a:ext cx="718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278080" y="9489960"/>
            <a:ext cx="295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.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07T05:30:02Z</dcterms:created>
  <dc:creator>tain</dc:creator>
  <dc:description/>
  <dc:language>en-US</dc:language>
  <cp:lastModifiedBy>user</cp:lastModifiedBy>
  <dcterms:modified xsi:type="dcterms:W3CDTF">2009-05-13T12:55:42Z</dcterms:modified>
  <cp:revision>224</cp:revision>
  <dc:subject/>
  <dc:title>投影片 1</dc:title>
</cp:coreProperties>
</file>